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大江 悠希" initials="大江" lastIdx="28" clrIdx="0">
    <p:extLst>
      <p:ext uri="{19B8F6BF-5375-455C-9EA6-DF929625EA0E}">
        <p15:presenceInfo xmlns:p15="http://schemas.microsoft.com/office/powerpoint/2012/main" userId="16ab6fb982198698" providerId="Windows Live"/>
      </p:ext>
    </p:extLst>
  </p:cmAuthor>
  <p:cmAuthor id="2" name="野本　博司" initials="野本　博司" lastIdx="4" clrIdx="1">
    <p:extLst>
      <p:ext uri="{19B8F6BF-5375-455C-9EA6-DF929625EA0E}">
        <p15:presenceInfo xmlns:p15="http://schemas.microsoft.com/office/powerpoint/2012/main" userId="野本　博司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>
      <p:cViewPr varScale="1">
        <p:scale>
          <a:sx n="107" d="100"/>
          <a:sy n="107" d="100"/>
        </p:scale>
        <p:origin x="384" y="10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MBG解析用!$E$19</c:f>
              <c:strCache>
                <c:ptCount val="1"/>
                <c:pt idx="0">
                  <c:v>前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diamond"/>
            <c:size val="20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MBG解析用!$G$20:$G$33</c:f>
                <c:numCache>
                  <c:formatCode>General</c:formatCode>
                  <c:ptCount val="14"/>
                  <c:pt idx="2">
                    <c:v>16.219376739510732</c:v>
                  </c:pt>
                  <c:pt idx="6">
                    <c:v>29.237144287029903</c:v>
                  </c:pt>
                  <c:pt idx="10">
                    <c:v>48.90482407883519</c:v>
                  </c:pt>
                  <c:pt idx="12">
                    <c:v>44.537075974558952</c:v>
                  </c:pt>
                </c:numCache>
              </c:numRef>
            </c:plus>
            <c:minus>
              <c:numRef>
                <c:f>SMBG解析用!$G$20:$G$33</c:f>
                <c:numCache>
                  <c:formatCode>General</c:formatCode>
                  <c:ptCount val="14"/>
                  <c:pt idx="2">
                    <c:v>16.219376739510732</c:v>
                  </c:pt>
                  <c:pt idx="6">
                    <c:v>29.237144287029903</c:v>
                  </c:pt>
                  <c:pt idx="10">
                    <c:v>48.90482407883519</c:v>
                  </c:pt>
                  <c:pt idx="12">
                    <c:v>44.5370759745589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MBG解析用!$D$20:$D$33</c:f>
              <c:strCache>
                <c:ptCount val="13"/>
                <c:pt idx="0">
                  <c:v>3-6時</c:v>
                </c:pt>
                <c:pt idx="2">
                  <c:v>朝食時</c:v>
                </c:pt>
                <c:pt idx="4">
                  <c:v>10-12時</c:v>
                </c:pt>
                <c:pt idx="6">
                  <c:v>昼食時</c:v>
                </c:pt>
                <c:pt idx="8">
                  <c:v>14-18時</c:v>
                </c:pt>
                <c:pt idx="10">
                  <c:v>夕食時</c:v>
                </c:pt>
                <c:pt idx="12">
                  <c:v>21-0時</c:v>
                </c:pt>
              </c:strCache>
            </c:strRef>
          </c:cat>
          <c:val>
            <c:numRef>
              <c:f>SMBG解析用!$E$20:$E$33</c:f>
              <c:numCache>
                <c:formatCode>General</c:formatCode>
                <c:ptCount val="14"/>
                <c:pt idx="2">
                  <c:v>116.25</c:v>
                </c:pt>
                <c:pt idx="6">
                  <c:v>135.58333333333334</c:v>
                </c:pt>
                <c:pt idx="10">
                  <c:v>152.5</c:v>
                </c:pt>
                <c:pt idx="12">
                  <c:v>189.1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147-4B3E-BBDE-43F93C7D50F8}"/>
            </c:ext>
          </c:extLst>
        </c:ser>
        <c:ser>
          <c:idx val="1"/>
          <c:order val="1"/>
          <c:tx>
            <c:strRef>
              <c:f>SMBG解析用!$F$19</c:f>
              <c:strCache>
                <c:ptCount val="1"/>
                <c:pt idx="0">
                  <c:v>後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20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MBG解析用!$H$20:$H$33</c:f>
                <c:numCache>
                  <c:formatCode>General</c:formatCode>
                  <c:ptCount val="14"/>
                  <c:pt idx="3">
                    <c:v>25.293729010818616</c:v>
                  </c:pt>
                  <c:pt idx="7">
                    <c:v>21.326599908010738</c:v>
                  </c:pt>
                  <c:pt idx="11">
                    <c:v>30.101218137034461</c:v>
                  </c:pt>
                  <c:pt idx="13">
                    <c:v>43.713664564950072</c:v>
                  </c:pt>
                </c:numCache>
              </c:numRef>
            </c:plus>
            <c:minus>
              <c:numRef>
                <c:f>SMBG解析用!$H$20:$H$33</c:f>
                <c:numCache>
                  <c:formatCode>General</c:formatCode>
                  <c:ptCount val="14"/>
                  <c:pt idx="3">
                    <c:v>25.293729010818616</c:v>
                  </c:pt>
                  <c:pt idx="7">
                    <c:v>21.326599908010738</c:v>
                  </c:pt>
                  <c:pt idx="11">
                    <c:v>30.101218137034461</c:v>
                  </c:pt>
                  <c:pt idx="13">
                    <c:v>43.7136645649500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MBG解析用!$D$20:$D$33</c:f>
              <c:strCache>
                <c:ptCount val="13"/>
                <c:pt idx="0">
                  <c:v>3-6時</c:v>
                </c:pt>
                <c:pt idx="2">
                  <c:v>朝食時</c:v>
                </c:pt>
                <c:pt idx="4">
                  <c:v>10-12時</c:v>
                </c:pt>
                <c:pt idx="6">
                  <c:v>昼食時</c:v>
                </c:pt>
                <c:pt idx="8">
                  <c:v>14-18時</c:v>
                </c:pt>
                <c:pt idx="10">
                  <c:v>夕食時</c:v>
                </c:pt>
                <c:pt idx="12">
                  <c:v>21-0時</c:v>
                </c:pt>
              </c:strCache>
            </c:strRef>
          </c:cat>
          <c:val>
            <c:numRef>
              <c:f>SMBG解析用!$F$20:$F$33</c:f>
              <c:numCache>
                <c:formatCode>General</c:formatCode>
                <c:ptCount val="14"/>
                <c:pt idx="3">
                  <c:v>115.5</c:v>
                </c:pt>
                <c:pt idx="7">
                  <c:v>124.875</c:v>
                </c:pt>
                <c:pt idx="11">
                  <c:v>128.91666666666666</c:v>
                </c:pt>
                <c:pt idx="13">
                  <c:v>173.4583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147-4B3E-BBDE-43F93C7D50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49431768"/>
        <c:axId val="749432096"/>
      </c:lineChart>
      <c:catAx>
        <c:axId val="7494317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49432096"/>
        <c:crosses val="autoZero"/>
        <c:auto val="1"/>
        <c:lblAlgn val="ctr"/>
        <c:lblOffset val="100"/>
        <c:noMultiLvlLbl val="0"/>
      </c:catAx>
      <c:valAx>
        <c:axId val="7494320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49431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AFDAEB-45A1-4E29-9A90-A4C944EA20C7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E46B05-C02E-429D-9E2D-6895585D22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4569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さらに、</a:t>
            </a:r>
            <a:r>
              <a:rPr kumimoji="1" lang="en-US" altLang="ja-JP" dirty="0"/>
              <a:t>MODD</a:t>
            </a:r>
            <a:r>
              <a:rPr kumimoji="1" lang="ja-JP" altLang="en-US" dirty="0"/>
              <a:t>、</a:t>
            </a:r>
            <a:r>
              <a:rPr kumimoji="1" lang="en-US" altLang="ja-JP" dirty="0"/>
              <a:t>ADRR</a:t>
            </a:r>
            <a:r>
              <a:rPr kumimoji="1" lang="ja-JP" altLang="en-US" dirty="0"/>
              <a:t>などの血糖日差変動についても、切り替えにより改善しておりました。</a:t>
            </a:r>
            <a:endParaRPr kumimoji="1" lang="en-US" altLang="ja-JP" dirty="0"/>
          </a:p>
          <a:p>
            <a:r>
              <a:rPr kumimoji="1" lang="en-US" altLang="ja-JP" dirty="0"/>
              <a:t>ADRR</a:t>
            </a:r>
            <a:r>
              <a:rPr kumimoji="1" lang="ja-JP" altLang="en-US" dirty="0"/>
              <a:t> </a:t>
            </a:r>
            <a:r>
              <a:rPr kumimoji="1" lang="en-US" altLang="ja-JP" dirty="0"/>
              <a:t>13mmol/L</a:t>
            </a:r>
            <a:r>
              <a:rPr kumimoji="1" lang="ja-JP" altLang="en-US" dirty="0"/>
              <a:t>で</a:t>
            </a:r>
            <a:r>
              <a:rPr kumimoji="1" lang="en-US" altLang="ja-JP" dirty="0"/>
              <a:t>&lt;20</a:t>
            </a:r>
            <a:r>
              <a:rPr kumimoji="1" lang="ja-JP" altLang="en-US" dirty="0"/>
              <a:t>なので</a:t>
            </a:r>
            <a:r>
              <a:rPr kumimoji="1" lang="en-US" altLang="ja-JP" dirty="0"/>
              <a:t>Low risk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05EDD7-0F82-4C37-B1C4-4874529B0055}" type="slidenum">
              <a:rPr lang="en-US" altLang="ja-JP" smtClean="0"/>
              <a:pPr/>
              <a:t>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9606829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97C455-F867-4A14-9B32-8527565CA6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3A2560C-76B6-4CE8-9A66-5F8765A66E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4C326E-1F9F-4DF7-9E4A-DE7B38DA2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471407-B95C-4B32-8BF5-7C7CB319E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BE684D-35E8-45DA-A807-68788E6EBA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5027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448F18-9618-4378-889A-B145C7C63D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4254552-9B8C-4D44-BC8D-279A33C746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FCFB152-77EE-481E-8DF6-B34FEFC93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1F627E-3151-42A7-A9E2-C8BD0790F0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31FC37-E834-4FF4-9DA2-30A92AB45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0408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3FEA80A-9028-4610-AA53-408E9A81B6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08F9B0D-7D2B-423C-A2E1-76644EF89B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47391BF-EB93-4857-BCDF-A1564EF70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DE4D3D-BADF-430B-849E-A2559F3CA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AD57007-A55E-4000-976F-B192E68D4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8084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5BD012-530A-4132-8F07-BD7DD5FFAF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DE2622-3E3B-4171-9F96-21A3EA69B3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17C22A-4C72-4116-A126-B0587F7E8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8F9B76-F82F-41FA-BA9E-DD880C235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BC47A1-7B1E-4E50-AC50-68861EBA4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5573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BD9358-4001-406D-AC16-D61C79604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C6D62C5-E44F-4D48-A970-DC1EF12CCF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BE9FF3-9213-4BED-807A-F4234A500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E89AC1-3ABC-4FD2-A1F5-CB89A630A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EEFD938-062F-4D50-B327-482F5D10C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7804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918EC2-8CF1-4D6A-A9FB-E155D697E5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DF19A28-D50F-4F45-AB63-4AE25F5964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AABBC53-DD7E-4D94-BE73-5EF054B00E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67805D2-C42D-4168-A695-F7E542B916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032421-5C74-4ADB-A062-2A4127967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4810A51-8500-48F7-A7D7-20B1533F9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4999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75FB47-9B2C-4D7A-94FE-F854C9C8AA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73B938F-9518-466B-8532-D911CB8AB4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0B33C91-E9FF-453C-9DCD-A1D8CE0079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D029135-FCEA-4E3C-9A1D-D3A312A6C4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5A87A31-F16E-4452-B774-94755EC2BB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F09E296-EAAD-4ACC-86EE-FB78C58E7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C9EA79F-CC40-46A9-98FA-91F0E81FC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75BF7AB-7C3F-4EA3-9B41-F613B8761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741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3B0196-9B95-4723-9FF5-E6392C549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C7E5C66-0364-4ADD-BF10-3072DDAB3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EB01716-E61E-4271-8628-72EE288C4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FAAF11C-267D-423D-8009-057A1339D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5721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39AF981-9221-4402-BB23-A654634D4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2481583-226C-4AE1-9AA5-50733F108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31F3947-1021-482E-8A3C-30E1F0EA9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276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8C6A98-7871-49BA-997A-0D8DA547E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2914971-D844-4675-9C91-60439324BA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8158420-EA23-4110-8C38-6678EC8B1B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E96C1D-7EB8-4B21-9EAD-1D458C6379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858314F-CA50-439D-AEC8-FF0B14231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5D28DCE-D2FF-4AF0-8FCA-C3B384E49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6775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3FFCC7-2B1F-4AFD-BAAA-D73E347FE6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BD58C93-4355-4AC0-AD98-A3D3B905E8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217E077-1530-4778-A676-7A2F4903F0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D68E29-1942-402B-B803-74D08EF0F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551EB1A-2440-47AB-9CAF-64F51F0E7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128EECA-0666-4B7D-8C45-E7092C18C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889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D78F638-1356-4D36-8CB7-A7E93274B3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C445B8D-BF03-4213-BA4B-54D907BEA1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D1BBBB9-CCF7-49D0-B87B-F018D5D18B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42F650-B21E-43E2-9E76-3AE72874C9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D443A8-878B-485D-A494-5A5135A28F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32959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F3E6EBE8-6320-4890-9E0F-4E16A538DD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4293421"/>
              </p:ext>
            </p:extLst>
          </p:nvPr>
        </p:nvGraphicFramePr>
        <p:xfrm>
          <a:off x="767408" y="1268760"/>
          <a:ext cx="10800000" cy="45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800D787-2A42-41BB-B4ED-22ACF89B9129}"/>
              </a:ext>
            </a:extLst>
          </p:cNvPr>
          <p:cNvSpPr txBox="1"/>
          <p:nvPr/>
        </p:nvSpPr>
        <p:spPr>
          <a:xfrm rot="16200000">
            <a:off x="-1163382" y="3460350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cose concentrations (m</a:t>
            </a:r>
            <a:r>
              <a:rPr kumimoji="1" lang="en-US" altLang="ja-JP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g/dL)</a:t>
            </a:r>
            <a:endParaRPr kumimoji="1" lang="ja-JP" altLang="en-US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E87DB773-117F-40DF-BF9F-277E197281D4}"/>
              </a:ext>
            </a:extLst>
          </p:cNvPr>
          <p:cNvSpPr txBox="1"/>
          <p:nvPr/>
        </p:nvSpPr>
        <p:spPr>
          <a:xfrm>
            <a:off x="1487488" y="5805264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dnight</a:t>
            </a:r>
            <a:endParaRPr kumimoji="1" lang="ja-JP" altLang="en-US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E0E3470-F82D-403B-968C-2DD3B81502FE}"/>
              </a:ext>
            </a:extLst>
          </p:cNvPr>
          <p:cNvSpPr txBox="1"/>
          <p:nvPr/>
        </p:nvSpPr>
        <p:spPr>
          <a:xfrm>
            <a:off x="2855640" y="5805264"/>
            <a:ext cx="13681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kumimoji="1" lang="en-US" altLang="ja-JP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Break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st</a:t>
            </a:r>
            <a:endParaRPr kumimoji="1" lang="ja-JP" altLang="en-US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8A0A95B-83E5-4D55-B7DD-0B3320200C22}"/>
              </a:ext>
            </a:extLst>
          </p:cNvPr>
          <p:cNvSpPr txBox="1"/>
          <p:nvPr/>
        </p:nvSpPr>
        <p:spPr>
          <a:xfrm>
            <a:off x="5795896" y="5805264"/>
            <a:ext cx="12241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endParaRPr kumimoji="1" lang="en-US" altLang="ja-JP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Lunch</a:t>
            </a:r>
            <a:endParaRPr kumimoji="1" lang="ja-JP" altLang="en-US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A1B60A9-FC22-4BB2-8B0A-2C6FA6C452EA}"/>
              </a:ext>
            </a:extLst>
          </p:cNvPr>
          <p:cNvSpPr txBox="1"/>
          <p:nvPr/>
        </p:nvSpPr>
        <p:spPr>
          <a:xfrm>
            <a:off x="8665706" y="5805264"/>
            <a:ext cx="12241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er</a:t>
            </a:r>
            <a:endParaRPr kumimoji="1" lang="ja-JP" altLang="en-US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FFA6AFD-A4B1-4606-AE1A-ABA2D42BF998}"/>
              </a:ext>
            </a:extLst>
          </p:cNvPr>
          <p:cNvSpPr txBox="1"/>
          <p:nvPr/>
        </p:nvSpPr>
        <p:spPr>
          <a:xfrm>
            <a:off x="4295800" y="5805264"/>
            <a:ext cx="13681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After Break</a:t>
            </a:r>
            <a:r>
              <a:rPr lang="en-US" altLang="ja-JP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st</a:t>
            </a:r>
            <a:endParaRPr kumimoji="1" lang="ja-JP" altLang="en-US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47F3B19F-5EFF-4E8D-A826-6D86D2B3D4A7}"/>
              </a:ext>
            </a:extLst>
          </p:cNvPr>
          <p:cNvSpPr txBox="1"/>
          <p:nvPr/>
        </p:nvSpPr>
        <p:spPr>
          <a:xfrm>
            <a:off x="7164047" y="5805264"/>
            <a:ext cx="13681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Lunch</a:t>
            </a:r>
            <a:endParaRPr kumimoji="1" lang="ja-JP" altLang="en-US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12C95D0-B910-4972-9D24-81B844FF365E}"/>
              </a:ext>
            </a:extLst>
          </p:cNvPr>
          <p:cNvSpPr txBox="1"/>
          <p:nvPr/>
        </p:nvSpPr>
        <p:spPr>
          <a:xfrm>
            <a:off x="10098480" y="5805264"/>
            <a:ext cx="12241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er</a:t>
            </a:r>
            <a:endParaRPr kumimoji="1" lang="ja-JP" altLang="en-US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左大かっこ 51">
            <a:extLst>
              <a:ext uri="{FF2B5EF4-FFF2-40B4-BE49-F238E27FC236}">
                <a16:creationId xmlns:a16="http://schemas.microsoft.com/office/drawing/2014/main" id="{BD335295-6992-42C2-98BA-E4C084D456D2}"/>
              </a:ext>
            </a:extLst>
          </p:cNvPr>
          <p:cNvSpPr/>
          <p:nvPr/>
        </p:nvSpPr>
        <p:spPr>
          <a:xfrm rot="5400000">
            <a:off x="3467716" y="2708952"/>
            <a:ext cx="144000" cy="72000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9BFD1849-57AA-4149-A88A-9DD7A5D7769D}"/>
              </a:ext>
            </a:extLst>
          </p:cNvPr>
          <p:cNvSpPr txBox="1"/>
          <p:nvPr/>
        </p:nvSpPr>
        <p:spPr>
          <a:xfrm>
            <a:off x="3071664" y="26369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</a:p>
        </p:txBody>
      </p:sp>
      <p:sp>
        <p:nvSpPr>
          <p:cNvPr id="72" name="左大かっこ 71">
            <a:extLst>
              <a:ext uri="{FF2B5EF4-FFF2-40B4-BE49-F238E27FC236}">
                <a16:creationId xmlns:a16="http://schemas.microsoft.com/office/drawing/2014/main" id="{4EF95834-DA47-4D42-8B52-3633B822FEAA}"/>
              </a:ext>
            </a:extLst>
          </p:cNvPr>
          <p:cNvSpPr/>
          <p:nvPr/>
        </p:nvSpPr>
        <p:spPr>
          <a:xfrm rot="5400000">
            <a:off x="10638548" y="1215256"/>
            <a:ext cx="144000" cy="72000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B39F63EB-13BB-47B0-BD14-C5B878BBBF6A}"/>
              </a:ext>
            </a:extLst>
          </p:cNvPr>
          <p:cNvSpPr txBox="1"/>
          <p:nvPr/>
        </p:nvSpPr>
        <p:spPr>
          <a:xfrm>
            <a:off x="10242496" y="1124744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9</a:t>
            </a:r>
          </a:p>
        </p:txBody>
      </p:sp>
      <p:sp>
        <p:nvSpPr>
          <p:cNvPr id="74" name="左大かっこ 73">
            <a:extLst>
              <a:ext uri="{FF2B5EF4-FFF2-40B4-BE49-F238E27FC236}">
                <a16:creationId xmlns:a16="http://schemas.microsoft.com/office/drawing/2014/main" id="{240D176D-F687-468F-858C-E265F5B6AA5C}"/>
              </a:ext>
            </a:extLst>
          </p:cNvPr>
          <p:cNvSpPr/>
          <p:nvPr/>
        </p:nvSpPr>
        <p:spPr>
          <a:xfrm rot="5400000">
            <a:off x="6335964" y="2276904"/>
            <a:ext cx="144000" cy="72000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3F0C05D-2DAA-40C0-89C9-D37239A5E6C5}"/>
              </a:ext>
            </a:extLst>
          </p:cNvPr>
          <p:cNvSpPr txBox="1"/>
          <p:nvPr/>
        </p:nvSpPr>
        <p:spPr>
          <a:xfrm>
            <a:off x="5939912" y="227687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左大かっこ 79">
            <a:extLst>
              <a:ext uri="{FF2B5EF4-FFF2-40B4-BE49-F238E27FC236}">
                <a16:creationId xmlns:a16="http://schemas.microsoft.com/office/drawing/2014/main" id="{BBEB21D8-6A68-426A-B8D9-33EB377F7781}"/>
              </a:ext>
            </a:extLst>
          </p:cNvPr>
          <p:cNvSpPr/>
          <p:nvPr/>
        </p:nvSpPr>
        <p:spPr>
          <a:xfrm rot="5400000">
            <a:off x="9205774" y="1772848"/>
            <a:ext cx="144000" cy="72000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4D4DF8C0-612A-4255-901A-BC65C174FFA0}"/>
              </a:ext>
            </a:extLst>
          </p:cNvPr>
          <p:cNvSpPr txBox="1"/>
          <p:nvPr/>
        </p:nvSpPr>
        <p:spPr>
          <a:xfrm>
            <a:off x="8809722" y="179430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CF603F2-5195-455E-9E98-8586A33213B1}"/>
              </a:ext>
            </a:extLst>
          </p:cNvPr>
          <p:cNvSpPr txBox="1"/>
          <p:nvPr/>
        </p:nvSpPr>
        <p:spPr>
          <a:xfrm>
            <a:off x="44460" y="72009"/>
            <a:ext cx="2800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0343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6</TotalTime>
  <Words>61</Words>
  <Application>Microsoft Office PowerPoint</Application>
  <PresentationFormat>ワイド画面</PresentationFormat>
  <Paragraphs>2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江 悠希</dc:creator>
  <cp:lastModifiedBy>野本　博司</cp:lastModifiedBy>
  <cp:revision>59</cp:revision>
  <dcterms:created xsi:type="dcterms:W3CDTF">2021-05-30T14:19:00Z</dcterms:created>
  <dcterms:modified xsi:type="dcterms:W3CDTF">2021-12-22T09:57:45Z</dcterms:modified>
</cp:coreProperties>
</file>